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Lawrenson (JIC)" initials="TL(" lastIdx="1" clrIdx="0">
    <p:extLst>
      <p:ext uri="{19B8F6BF-5375-455C-9EA6-DF929625EA0E}">
        <p15:presenceInfo xmlns:p15="http://schemas.microsoft.com/office/powerpoint/2012/main" userId="S::lawrenso@nbi.ac.uk::2620944d-b538-4253-9c24-ef77a72e45f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3F38A-F027-4291-B7D2-0E22CEB8F4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382B09-BBAD-4F1F-968F-37D4B149FE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4B267-8149-4044-8CDB-EC996A608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7FB988-ED2F-4BD4-9F3D-03D28D708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8815A9-0077-413C-A3C9-7994EC1E6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448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2491DC-88DC-4D3B-B2B7-487F1CE330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C6A478-E31D-48AA-A044-F1429E2C0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D2090-9BF7-4CA2-9E42-FD2F40478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688243-9493-4558-B7F3-2B0968C0C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AD73B9-09E4-4C4B-A7CA-64232E71E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800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EC3D51-E146-4962-B817-5E4DEC002C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3D1694-12FF-4849-B486-613718E5CE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D68798-2B98-46C0-B627-01D309906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8576E7-2D41-4E8D-AAC0-3CB1E2513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64B3A9-F644-4687-AB7B-9065AD3C8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63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616F6-D2AB-4306-9B0A-B1BC618DA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11485D-EB63-45A1-950B-C8D1BE8E8D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687D61-5182-4612-B81D-7AE84924A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56E30-09C4-44E0-8DBC-87BC29F6E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0159AA-1A73-4BCC-872E-445DA5F3E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5513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D49615-4C79-44B7-8B6F-C0C0CAAB4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915A4B-98C9-4195-8038-7EC0477A56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8DA20A-40E9-4671-92E0-4A56C915A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CED771-6CF2-4097-B60A-6C592D537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E2C3FB-AA2F-451F-8C8C-273F6AB23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715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31305-8BE7-4FD7-9190-BDA0D4C82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FF507A-CE91-4179-AE9B-DDA732E929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3D254D-428A-4B3D-8654-3CE7D52CAE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8AAA3-8C93-488D-90D1-7572FDB77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8E801F-11DE-4589-9E5F-656BE95AB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D648A0-1F0B-4230-90AC-7CFB20697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135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625BBC-9ADB-4A78-988C-1CC35C545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A6F03F-8426-47CF-BEAF-EA8ACE8A67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7C1331-5441-4D82-9F17-106FA50E3B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574062-B820-42B3-AC83-6DA1B42804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90173F-4294-4321-A9C1-8CD290E3F2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5FEBCC-BCDB-4F29-8E66-4D251D659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FAED0F-BA7C-4538-9E20-557355B60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FC5978-05DD-4B87-8862-E776A3D60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7432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DFF0D-125F-4E85-95F5-B3669ED95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BFCE6F-D253-44D1-8EA0-EFAFD67F2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2754BD-2D92-42A2-9299-3C6D7888D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FD6B9A-7E1D-452E-82D2-25D2AC39D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438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4AD5B1-E9FC-4F0D-A8CC-DAB17666D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2A2D5A-3FA5-4249-867C-DFA12836E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521F02-B205-4402-BF0F-9DFA1A7FE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814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C9493-B9D4-434B-B65B-0CFCC68CD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B07D6-3D1A-4509-8406-1F85C2AA8E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399AF-0FF4-4C50-8231-49E825AAFE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4CCCFA-6735-4F76-A84C-65B0A308C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020DF6-53C8-42D0-8984-D1C47F9DD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0D50F6-036A-49BB-BAE8-BF6D1CD7E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569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DCFE9D-5C59-4241-9942-AABB3DE39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28BC9C-CFA1-489D-9492-022E71830C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836BC0-DF87-4F32-9875-29F4E9018F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7CABD7-7D83-4E87-B968-B348C1E8B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86911-0641-429A-8D45-90F9DBBF0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454E6A-9A2E-4F96-81A3-4F9AC872C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8774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4834C0-5B62-41E8-97AF-34CA4B6A9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DDA361-8ACD-4890-AF36-64AF460EA6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7333D3-1F2C-40EA-8445-7CE3A6B6C9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107FF-82D1-463F-B3E8-C0025B541316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5043B7-4D0A-46AF-916F-354D0B2932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60E67-E33A-4189-84EA-B01A9055FA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F0588-69F0-478A-8647-C16B782098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2844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880DF7-5D1D-43A7-B72B-E4358BB532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430" t="62983" r="21432" b="20032"/>
          <a:stretch/>
        </p:blipFill>
        <p:spPr>
          <a:xfrm rot="10800000">
            <a:off x="3386975" y="1494355"/>
            <a:ext cx="4749860" cy="203709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BFA2D1B-19A1-4B1A-AA50-1725DB18985D}"/>
              </a:ext>
            </a:extLst>
          </p:cNvPr>
          <p:cNvSpPr txBox="1"/>
          <p:nvPr/>
        </p:nvSpPr>
        <p:spPr>
          <a:xfrm rot="16200000">
            <a:off x="3988905" y="1921564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262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B6EC3-0FA1-4F56-8373-4E5E01A13D5F}"/>
              </a:ext>
            </a:extLst>
          </p:cNvPr>
          <p:cNvSpPr txBox="1"/>
          <p:nvPr/>
        </p:nvSpPr>
        <p:spPr>
          <a:xfrm rot="16200000">
            <a:off x="4419601" y="1921564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131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EB7039-A0FE-49E8-B50D-A092D4F24676}"/>
              </a:ext>
            </a:extLst>
          </p:cNvPr>
          <p:cNvSpPr txBox="1"/>
          <p:nvPr/>
        </p:nvSpPr>
        <p:spPr>
          <a:xfrm rot="16200000">
            <a:off x="4889570" y="196083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65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FD0D49C-69C3-4F55-A235-F4E42731CF91}"/>
              </a:ext>
            </a:extLst>
          </p:cNvPr>
          <p:cNvSpPr txBox="1"/>
          <p:nvPr/>
        </p:nvSpPr>
        <p:spPr>
          <a:xfrm rot="16200000">
            <a:off x="5339507" y="196083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32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D925DA-6F10-432A-97C5-D7B3C44B8CBD}"/>
              </a:ext>
            </a:extLst>
          </p:cNvPr>
          <p:cNvSpPr txBox="1"/>
          <p:nvPr/>
        </p:nvSpPr>
        <p:spPr>
          <a:xfrm rot="16200000">
            <a:off x="5776192" y="200011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16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F04A9E-88C0-44DD-A33E-FEFD8FB81A57}"/>
              </a:ext>
            </a:extLst>
          </p:cNvPr>
          <p:cNvSpPr txBox="1"/>
          <p:nvPr/>
        </p:nvSpPr>
        <p:spPr>
          <a:xfrm rot="16200000">
            <a:off x="6219658" y="200011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8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E6ED99-C7FB-450C-BF3A-6C44CC4529A7}"/>
              </a:ext>
            </a:extLst>
          </p:cNvPr>
          <p:cNvSpPr txBox="1"/>
          <p:nvPr/>
        </p:nvSpPr>
        <p:spPr>
          <a:xfrm rot="16200000">
            <a:off x="6663607" y="203938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4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4AB5540-7217-4855-BE8E-8B98187CAAB8}"/>
              </a:ext>
            </a:extLst>
          </p:cNvPr>
          <p:cNvSpPr txBox="1"/>
          <p:nvPr/>
        </p:nvSpPr>
        <p:spPr>
          <a:xfrm rot="16200000">
            <a:off x="6969056" y="203938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C56CA3-DF37-468A-A0C5-6748064FE03B}"/>
              </a:ext>
            </a:extLst>
          </p:cNvPr>
          <p:cNvSpPr txBox="1"/>
          <p:nvPr/>
        </p:nvSpPr>
        <p:spPr>
          <a:xfrm>
            <a:off x="4099834" y="1547486"/>
            <a:ext cx="3178602" cy="338554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             Copies of construct D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85DA88-D5C7-4A7A-BF27-E64DFC819837}"/>
              </a:ext>
            </a:extLst>
          </p:cNvPr>
          <p:cNvSpPr txBox="1"/>
          <p:nvPr/>
        </p:nvSpPr>
        <p:spPr>
          <a:xfrm>
            <a:off x="10735057" y="29711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S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C5B50EA-E7E1-4F55-A2D6-F3CFA4794C15}"/>
              </a:ext>
            </a:extLst>
          </p:cNvPr>
          <p:cNvSpPr txBox="1"/>
          <p:nvPr/>
        </p:nvSpPr>
        <p:spPr>
          <a:xfrm>
            <a:off x="520117" y="4479721"/>
            <a:ext cx="112574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</a:t>
            </a:r>
          </a:p>
          <a:p>
            <a:endParaRPr lang="en-GB" sz="1200" dirty="0"/>
          </a:p>
          <a:p>
            <a:r>
              <a:rPr lang="en-GB" sz="1200" dirty="0"/>
              <a:t>Gel showing sensitivity obtained in F1/R1 PCR screen setup. Construct D was transformed into barley and DNA extracted from a regenerated plant (transgene copy number 1) and quantified by Qubit fluorescence. Serial dilutions were made of this DNA for subsequent PCR. The copy number of transgene D are shown for each lane. The limit of detection is around 40 copies of the target.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A25782DC-20B8-45A6-8808-4545531737B8}"/>
              </a:ext>
            </a:extLst>
          </p:cNvPr>
          <p:cNvSpPr/>
          <p:nvPr/>
        </p:nvSpPr>
        <p:spPr>
          <a:xfrm>
            <a:off x="2910410" y="2580013"/>
            <a:ext cx="328474" cy="14962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213583-DFBF-4B89-AEF0-3C33E4499054}"/>
              </a:ext>
            </a:extLst>
          </p:cNvPr>
          <p:cNvSpPr txBox="1"/>
          <p:nvPr/>
        </p:nvSpPr>
        <p:spPr>
          <a:xfrm>
            <a:off x="2361862" y="2525626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972bp</a:t>
            </a:r>
          </a:p>
        </p:txBody>
      </p:sp>
    </p:spTree>
    <p:extLst>
      <p:ext uri="{BB962C8B-B14F-4D97-AF65-F5344CB8AC3E}">
        <p14:creationId xmlns:p14="http://schemas.microsoft.com/office/powerpoint/2010/main" val="1581871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Lawrenson (JIC)</dc:creator>
  <cp:lastModifiedBy>Wendy Harwood (JIC)</cp:lastModifiedBy>
  <cp:revision>4</cp:revision>
  <dcterms:created xsi:type="dcterms:W3CDTF">2021-01-13T11:37:06Z</dcterms:created>
  <dcterms:modified xsi:type="dcterms:W3CDTF">2021-04-27T17:32:24Z</dcterms:modified>
</cp:coreProperties>
</file>